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418" r:id="rId2"/>
    <p:sldId id="419" r:id="rId3"/>
    <p:sldId id="420" r:id="rId4"/>
    <p:sldId id="421" r:id="rId5"/>
  </p:sldIdLst>
  <p:sldSz cx="6858000" cy="9144000" type="screen4x3"/>
  <p:notesSz cx="9866313" cy="67357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0DADCBF8-FA06-4B44-BE69-44DD35D33BDB}">
          <p14:sldIdLst>
            <p14:sldId id="418"/>
            <p14:sldId id="419"/>
            <p14:sldId id="420"/>
            <p14:sldId id="421"/>
          </p14:sldIdLst>
        </p14:section>
      </p14:sectionLst>
    </p:ex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66FFFF"/>
    <a:srgbClr val="FF6600"/>
    <a:srgbClr val="FF9900"/>
    <a:srgbClr val="FFCCCC"/>
    <a:srgbClr val="E2F0D9"/>
    <a:srgbClr val="FFCC66"/>
    <a:srgbClr val="FFCC00"/>
    <a:srgbClr val="FFCC99"/>
    <a:srgbClr val="99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3A801E-1A91-4E3C-918C-79104B4CE9B1}" v="7" dt="2025-02-25T05:06:52.31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844" autoAdjust="0"/>
    <p:restoredTop sz="96115" autoAdjust="0"/>
  </p:normalViewPr>
  <p:slideViewPr>
    <p:cSldViewPr snapToGrid="0" showGuides="1">
      <p:cViewPr varScale="1">
        <p:scale>
          <a:sx n="78" d="100"/>
          <a:sy n="78" d="100"/>
        </p:scale>
        <p:origin x="3552" y="96"/>
      </p:cViewPr>
      <p:guideLst>
        <p:guide pos="2160"/>
        <p:guide orient="horz"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薫 山形" userId="f3f449f0fe72d00b" providerId="LiveId" clId="{783A801E-1A91-4E3C-918C-79104B4CE9B1}"/>
    <pc:docChg chg="undo custSel modSld">
      <pc:chgData name="薫 山形" userId="f3f449f0fe72d00b" providerId="LiveId" clId="{783A801E-1A91-4E3C-918C-79104B4CE9B1}" dt="2025-02-25T05:26:11.858" v="188" actId="1036"/>
      <pc:docMkLst>
        <pc:docMk/>
      </pc:docMkLst>
      <pc:sldChg chg="addSp modSp mod">
        <pc:chgData name="薫 山形" userId="f3f449f0fe72d00b" providerId="LiveId" clId="{783A801E-1A91-4E3C-918C-79104B4CE9B1}" dt="2025-02-25T05:07:29.287" v="86" actId="1038"/>
        <pc:sldMkLst>
          <pc:docMk/>
          <pc:sldMk cId="2568808867" sldId="362"/>
        </pc:sldMkLst>
        <pc:spChg chg="add mod">
          <ac:chgData name="薫 山形" userId="f3f449f0fe72d00b" providerId="LiveId" clId="{783A801E-1A91-4E3C-918C-79104B4CE9B1}" dt="2025-02-25T05:07:20.692" v="81" actId="1035"/>
          <ac:spMkLst>
            <pc:docMk/>
            <pc:sldMk cId="2568808867" sldId="362"/>
            <ac:spMk id="2" creationId="{8935C52B-B332-6637-E0D8-4D723FBD315C}"/>
          </ac:spMkLst>
        </pc:spChg>
        <pc:spChg chg="add mod">
          <ac:chgData name="薫 山形" userId="f3f449f0fe72d00b" providerId="LiveId" clId="{783A801E-1A91-4E3C-918C-79104B4CE9B1}" dt="2025-02-25T05:07:29.287" v="86" actId="1038"/>
          <ac:spMkLst>
            <pc:docMk/>
            <pc:sldMk cId="2568808867" sldId="362"/>
            <ac:spMk id="3" creationId="{E003F365-E995-C6B9-36CD-63603BB31249}"/>
          </ac:spMkLst>
        </pc:spChg>
        <pc:spChg chg="mod">
          <ac:chgData name="薫 山形" userId="f3f449f0fe72d00b" providerId="LiveId" clId="{783A801E-1A91-4E3C-918C-79104B4CE9B1}" dt="2025-02-24T14:45:27.415" v="4" actId="13926"/>
          <ac:spMkLst>
            <pc:docMk/>
            <pc:sldMk cId="2568808867" sldId="362"/>
            <ac:spMk id="31" creationId="{EF627DF2-67C8-E7F1-1483-17C80B126048}"/>
          </ac:spMkLst>
        </pc:spChg>
      </pc:sldChg>
      <pc:sldChg chg="modSp mod">
        <pc:chgData name="薫 山形" userId="f3f449f0fe72d00b" providerId="LiveId" clId="{783A801E-1A91-4E3C-918C-79104B4CE9B1}" dt="2025-02-25T05:02:31.768" v="70" actId="1037"/>
        <pc:sldMkLst>
          <pc:docMk/>
          <pc:sldMk cId="1437449611" sldId="380"/>
        </pc:sldMkLst>
        <pc:cxnChg chg="mod">
          <ac:chgData name="薫 山形" userId="f3f449f0fe72d00b" providerId="LiveId" clId="{783A801E-1A91-4E3C-918C-79104B4CE9B1}" dt="2025-02-25T05:02:31.768" v="70" actId="1037"/>
          <ac:cxnSpMkLst>
            <pc:docMk/>
            <pc:sldMk cId="1437449611" sldId="380"/>
            <ac:cxnSpMk id="66" creationId="{83C47A76-B699-EE67-4B55-8B7B76EFFC7D}"/>
          </ac:cxnSpMkLst>
        </pc:cxnChg>
      </pc:sldChg>
      <pc:sldChg chg="modSp mod">
        <pc:chgData name="薫 山形" userId="f3f449f0fe72d00b" providerId="LiveId" clId="{783A801E-1A91-4E3C-918C-79104B4CE9B1}" dt="2025-02-24T14:44:31.645" v="2" actId="13926"/>
        <pc:sldMkLst>
          <pc:docMk/>
          <pc:sldMk cId="2351788407" sldId="386"/>
        </pc:sldMkLst>
        <pc:spChg chg="mod">
          <ac:chgData name="薫 山形" userId="f3f449f0fe72d00b" providerId="LiveId" clId="{783A801E-1A91-4E3C-918C-79104B4CE9B1}" dt="2025-02-24T14:44:31.645" v="2" actId="13926"/>
          <ac:spMkLst>
            <pc:docMk/>
            <pc:sldMk cId="2351788407" sldId="386"/>
            <ac:spMk id="15" creationId="{C9471BF3-19EF-6F4F-458C-306FF50E6983}"/>
          </ac:spMkLst>
        </pc:spChg>
        <pc:spChg chg="mod">
          <ac:chgData name="薫 山形" userId="f3f449f0fe72d00b" providerId="LiveId" clId="{783A801E-1A91-4E3C-918C-79104B4CE9B1}" dt="2025-02-24T14:44:27.731" v="1" actId="13926"/>
          <ac:spMkLst>
            <pc:docMk/>
            <pc:sldMk cId="2351788407" sldId="386"/>
            <ac:spMk id="69" creationId="{282122E5-3693-53C7-1A41-F10246A6AB98}"/>
          </ac:spMkLst>
        </pc:spChg>
        <pc:spChg chg="mod">
          <ac:chgData name="薫 山形" userId="f3f449f0fe72d00b" providerId="LiveId" clId="{783A801E-1A91-4E3C-918C-79104B4CE9B1}" dt="2025-02-24T14:43:57.984" v="0" actId="13926"/>
          <ac:spMkLst>
            <pc:docMk/>
            <pc:sldMk cId="2351788407" sldId="386"/>
            <ac:spMk id="70" creationId="{95DC1D41-421E-3429-3B3B-70D6A56C7B81}"/>
          </ac:spMkLst>
        </pc:spChg>
      </pc:sldChg>
      <pc:sldChg chg="modSp mod">
        <pc:chgData name="薫 山形" userId="f3f449f0fe72d00b" providerId="LiveId" clId="{783A801E-1A91-4E3C-918C-79104B4CE9B1}" dt="2025-02-25T04:04:45.500" v="11" actId="1038"/>
        <pc:sldMkLst>
          <pc:docMk/>
          <pc:sldMk cId="4188892786" sldId="388"/>
        </pc:sldMkLst>
        <pc:spChg chg="mod">
          <ac:chgData name="薫 山形" userId="f3f449f0fe72d00b" providerId="LiveId" clId="{783A801E-1A91-4E3C-918C-79104B4CE9B1}" dt="2025-02-25T04:04:45.500" v="11" actId="1038"/>
          <ac:spMkLst>
            <pc:docMk/>
            <pc:sldMk cId="4188892786" sldId="388"/>
            <ac:spMk id="29" creationId="{39FD4487-94A7-DE1C-5740-0573E0E63FE3}"/>
          </ac:spMkLst>
        </pc:spChg>
      </pc:sldChg>
      <pc:sldChg chg="addSp delSp modSp mod">
        <pc:chgData name="薫 山形" userId="f3f449f0fe72d00b" providerId="LiveId" clId="{783A801E-1A91-4E3C-918C-79104B4CE9B1}" dt="2025-02-25T04:13:52.153" v="67" actId="478"/>
        <pc:sldMkLst>
          <pc:docMk/>
          <pc:sldMk cId="2736125647" sldId="398"/>
        </pc:sldMkLst>
        <pc:spChg chg="mod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14" creationId="{D2E58351-1EBC-376E-0B95-7C1772632735}"/>
          </ac:spMkLst>
        </pc:spChg>
        <pc:spChg chg="mod topLvl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24" creationId="{856AB56F-1DE2-4510-BA0D-4197F2929C22}"/>
          </ac:spMkLst>
        </pc:spChg>
        <pc:spChg chg="mod topLvl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25" creationId="{6715110E-44E4-1D56-8544-816B6A67105F}"/>
          </ac:spMkLst>
        </pc:spChg>
        <pc:spChg chg="mod">
          <ac:chgData name="薫 山形" userId="f3f449f0fe72d00b" providerId="LiveId" clId="{783A801E-1A91-4E3C-918C-79104B4CE9B1}" dt="2025-02-25T04:12:14.638" v="53" actId="555"/>
          <ac:spMkLst>
            <pc:docMk/>
            <pc:sldMk cId="2736125647" sldId="398"/>
            <ac:spMk id="30" creationId="{64F858B2-6BB9-B323-6C3D-B0E58CFFDA9B}"/>
          </ac:spMkLst>
        </pc:spChg>
        <pc:spChg chg="add mod">
          <ac:chgData name="薫 山形" userId="f3f449f0fe72d00b" providerId="LiveId" clId="{783A801E-1A91-4E3C-918C-79104B4CE9B1}" dt="2025-02-25T04:12:42.522" v="66" actId="1036"/>
          <ac:spMkLst>
            <pc:docMk/>
            <pc:sldMk cId="2736125647" sldId="398"/>
            <ac:spMk id="31" creationId="{5052F492-995E-C482-89F9-ED95344D13CC}"/>
          </ac:spMkLst>
        </pc:spChg>
        <pc:spChg chg="mod">
          <ac:chgData name="薫 山形" userId="f3f449f0fe72d00b" providerId="LiveId" clId="{783A801E-1A91-4E3C-918C-79104B4CE9B1}" dt="2025-02-24T14:44:44.410" v="3" actId="13926"/>
          <ac:spMkLst>
            <pc:docMk/>
            <pc:sldMk cId="2736125647" sldId="398"/>
            <ac:spMk id="34" creationId="{D4DC4968-5F3C-AC43-BBE5-34A757072AC1}"/>
          </ac:spMkLst>
        </pc:spChg>
        <pc:spChg chg="mod topLvl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55" creationId="{4CB680FC-F160-A8DD-FD96-8A981E329774}"/>
          </ac:spMkLst>
        </pc:spChg>
        <pc:spChg chg="del mod">
          <ac:chgData name="薫 山形" userId="f3f449f0fe72d00b" providerId="LiveId" clId="{783A801E-1A91-4E3C-918C-79104B4CE9B1}" dt="2025-02-25T04:13:52.153" v="67" actId="478"/>
          <ac:spMkLst>
            <pc:docMk/>
            <pc:sldMk cId="2736125647" sldId="398"/>
            <ac:spMk id="61" creationId="{C63F4664-E845-BFA5-4EA2-066CBB7348BA}"/>
          </ac:spMkLst>
        </pc:spChg>
        <pc:spChg chg="mod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63" creationId="{554F88C0-2574-A211-07BA-2002F4A1599E}"/>
          </ac:spMkLst>
        </pc:spChg>
        <pc:spChg chg="mod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69" creationId="{3EC7689D-61E7-DE2F-8C37-14BB39E1711E}"/>
          </ac:spMkLst>
        </pc:spChg>
        <pc:spChg chg="mod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70" creationId="{FBBC720C-1D01-F9C2-A0D9-F891D0628C13}"/>
          </ac:spMkLst>
        </pc:spChg>
        <pc:spChg chg="mod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71" creationId="{ACD3FE53-3B4D-6E6F-56A4-341F9DFCBE0D}"/>
          </ac:spMkLst>
        </pc:spChg>
        <pc:spChg chg="mod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104" creationId="{CF439FE8-E92D-D913-7E4F-F4EE71A79F09}"/>
          </ac:spMkLst>
        </pc:spChg>
        <pc:spChg chg="mod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123" creationId="{EF4F4EF2-F3A1-211E-84F0-9AC61128903D}"/>
          </ac:spMkLst>
        </pc:spChg>
        <pc:spChg chg="mod topLvl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153" creationId="{EA11B7E5-DDBC-9852-2BA9-E68EB981236F}"/>
          </ac:spMkLst>
        </pc:spChg>
        <pc:spChg chg="mod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154" creationId="{30CFC48B-06B4-4A89-117A-12A01609008B}"/>
          </ac:spMkLst>
        </pc:spChg>
        <pc:spChg chg="mod topLvl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157" creationId="{5452F4FA-B9BD-39A2-CDC5-C97127D9B56C}"/>
          </ac:spMkLst>
        </pc:spChg>
        <pc:spChg chg="mod topLvl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159" creationId="{73CF80D4-AC86-0378-766C-46A535E3473C}"/>
          </ac:spMkLst>
        </pc:spChg>
        <pc:spChg chg="mod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163" creationId="{0E8036DA-7AB1-512F-4434-1C1E0D4B6B0F}"/>
          </ac:spMkLst>
        </pc:spChg>
        <pc:spChg chg="mod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164" creationId="{2CEF9AE1-F31E-2E81-E553-FFD42E740C1D}"/>
          </ac:spMkLst>
        </pc:spChg>
        <pc:spChg chg="mod">
          <ac:chgData name="薫 山形" userId="f3f449f0fe72d00b" providerId="LiveId" clId="{783A801E-1A91-4E3C-918C-79104B4CE9B1}" dt="2025-02-25T04:08:52.048" v="16" actId="164"/>
          <ac:spMkLst>
            <pc:docMk/>
            <pc:sldMk cId="2736125647" sldId="398"/>
            <ac:spMk id="165" creationId="{609BEFFF-9AA1-43C7-55DE-E8A4B31DA825}"/>
          </ac:spMkLst>
        </pc:spChg>
        <pc:spChg chg="mod">
          <ac:chgData name="薫 山形" userId="f3f449f0fe72d00b" providerId="LiveId" clId="{783A801E-1A91-4E3C-918C-79104B4CE9B1}" dt="2025-02-25T04:09:23.286" v="19" actId="164"/>
          <ac:spMkLst>
            <pc:docMk/>
            <pc:sldMk cId="2736125647" sldId="398"/>
            <ac:spMk id="208" creationId="{D1BCF496-2EA1-A5F7-22A3-76CECCFDD37F}"/>
          </ac:spMkLst>
        </pc:spChg>
        <pc:grpChg chg="del mod">
          <ac:chgData name="薫 山形" userId="f3f449f0fe72d00b" providerId="LiveId" clId="{783A801E-1A91-4E3C-918C-79104B4CE9B1}" dt="2025-02-25T04:09:07.820" v="17" actId="165"/>
          <ac:grpSpMkLst>
            <pc:docMk/>
            <pc:sldMk cId="2736125647" sldId="398"/>
            <ac:grpSpMk id="53" creationId="{A625E2FE-4728-CFE4-F9A3-E5C9B1B5F39F}"/>
          </ac:grpSpMkLst>
        </pc:grpChg>
        <pc:grpChg chg="del">
          <ac:chgData name="薫 山形" userId="f3f449f0fe72d00b" providerId="LiveId" clId="{783A801E-1A91-4E3C-918C-79104B4CE9B1}" dt="2025-02-25T04:08:36.050" v="14" actId="165"/>
          <ac:grpSpMkLst>
            <pc:docMk/>
            <pc:sldMk cId="2736125647" sldId="398"/>
            <ac:grpSpMk id="102" creationId="{29487D68-1022-56CE-7C39-8610703F70DD}"/>
          </ac:grpSpMkLst>
        </pc:grpChg>
        <pc:graphicFrameChg chg="mod topLvl">
          <ac:chgData name="薫 山形" userId="f3f449f0fe72d00b" providerId="LiveId" clId="{783A801E-1A91-4E3C-918C-79104B4CE9B1}" dt="2025-02-25T04:08:52.048" v="16" actId="164"/>
          <ac:graphicFrameMkLst>
            <pc:docMk/>
            <pc:sldMk cId="2736125647" sldId="398"/>
            <ac:graphicFrameMk id="9" creationId="{C8F4470E-FA20-7D35-4899-58A411BDB505}"/>
          </ac:graphicFrameMkLst>
        </pc:graphicFrameChg>
        <pc:graphicFrameChg chg="mod topLvl">
          <ac:chgData name="薫 山形" userId="f3f449f0fe72d00b" providerId="LiveId" clId="{783A801E-1A91-4E3C-918C-79104B4CE9B1}" dt="2025-02-25T04:09:23.286" v="19" actId="164"/>
          <ac:graphicFrameMkLst>
            <pc:docMk/>
            <pc:sldMk cId="2736125647" sldId="398"/>
            <ac:graphicFrameMk id="127" creationId="{8FDD9272-1861-ECA6-84E4-66A60E988677}"/>
          </ac:graphicFrameMkLst>
        </pc:graphicFrameChg>
        <pc:cxnChg chg="mod topLvl">
          <ac:chgData name="薫 山形" userId="f3f449f0fe72d00b" providerId="LiveId" clId="{783A801E-1A91-4E3C-918C-79104B4CE9B1}" dt="2025-02-25T04:08:36.050" v="14" actId="165"/>
          <ac:cxnSpMkLst>
            <pc:docMk/>
            <pc:sldMk cId="2736125647" sldId="398"/>
            <ac:cxnSpMk id="43" creationId="{23686580-F276-0DB3-250C-35359276D466}"/>
          </ac:cxnSpMkLst>
        </pc:cxnChg>
        <pc:cxnChg chg="mod topLvl">
          <ac:chgData name="薫 山形" userId="f3f449f0fe72d00b" providerId="LiveId" clId="{783A801E-1A91-4E3C-918C-79104B4CE9B1}" dt="2025-02-25T04:09:14.336" v="18" actId="1035"/>
          <ac:cxnSpMkLst>
            <pc:docMk/>
            <pc:sldMk cId="2736125647" sldId="398"/>
            <ac:cxnSpMk id="62" creationId="{3CAD6F0D-134D-0C44-BFFB-99A638D715D9}"/>
          </ac:cxnSpMkLst>
        </pc:cxnChg>
        <pc:cxnChg chg="mod">
          <ac:chgData name="薫 山形" userId="f3f449f0fe72d00b" providerId="LiveId" clId="{783A801E-1A91-4E3C-918C-79104B4CE9B1}" dt="2025-02-25T04:08:41.541" v="15" actId="1036"/>
          <ac:cxnSpMkLst>
            <pc:docMk/>
            <pc:sldMk cId="2736125647" sldId="398"/>
            <ac:cxnSpMk id="112" creationId="{CFA30CCB-CF0D-9AE4-C8A7-4A02E1FFA6E6}"/>
          </ac:cxnSpMkLst>
        </pc:cxnChg>
      </pc:sldChg>
      <pc:sldChg chg="modSp mod">
        <pc:chgData name="薫 山形" userId="f3f449f0fe72d00b" providerId="LiveId" clId="{783A801E-1A91-4E3C-918C-79104B4CE9B1}" dt="2025-02-25T05:21:16.472" v="115" actId="1035"/>
        <pc:sldMkLst>
          <pc:docMk/>
          <pc:sldMk cId="219075910" sldId="402"/>
        </pc:sldMkLst>
        <pc:spChg chg="mod">
          <ac:chgData name="薫 山形" userId="f3f449f0fe72d00b" providerId="LiveId" clId="{783A801E-1A91-4E3C-918C-79104B4CE9B1}" dt="2025-02-25T05:20:59.244" v="111" actId="1035"/>
          <ac:spMkLst>
            <pc:docMk/>
            <pc:sldMk cId="219075910" sldId="402"/>
            <ac:spMk id="24" creationId="{7B71EDCB-7018-BBD8-8F0F-2839FAEEDBD9}"/>
          </ac:spMkLst>
        </pc:spChg>
        <pc:spChg chg="mod">
          <ac:chgData name="薫 山形" userId="f3f449f0fe72d00b" providerId="LiveId" clId="{783A801E-1A91-4E3C-918C-79104B4CE9B1}" dt="2025-02-25T05:20:51.905" v="109" actId="1035"/>
          <ac:spMkLst>
            <pc:docMk/>
            <pc:sldMk cId="219075910" sldId="402"/>
            <ac:spMk id="25" creationId="{52A82623-5C35-42D3-2CA1-104F4FB3A6B8}"/>
          </ac:spMkLst>
        </pc:spChg>
        <pc:spChg chg="mod">
          <ac:chgData name="薫 山形" userId="f3f449f0fe72d00b" providerId="LiveId" clId="{783A801E-1A91-4E3C-918C-79104B4CE9B1}" dt="2025-02-25T05:18:56.621" v="96" actId="1035"/>
          <ac:spMkLst>
            <pc:docMk/>
            <pc:sldMk cId="219075910" sldId="402"/>
            <ac:spMk id="32" creationId="{506E4C1A-F32D-4660-1BF4-B3DF19B174AB}"/>
          </ac:spMkLst>
        </pc:spChg>
        <pc:spChg chg="mod">
          <ac:chgData name="薫 山形" userId="f3f449f0fe72d00b" providerId="LiveId" clId="{783A801E-1A91-4E3C-918C-79104B4CE9B1}" dt="2025-02-25T05:21:16.472" v="115" actId="1035"/>
          <ac:spMkLst>
            <pc:docMk/>
            <pc:sldMk cId="219075910" sldId="402"/>
            <ac:spMk id="43" creationId="{35CCCDA6-A58D-AC04-2740-55D0A8DAB970}"/>
          </ac:spMkLst>
        </pc:spChg>
        <pc:spChg chg="mod">
          <ac:chgData name="薫 山形" userId="f3f449f0fe72d00b" providerId="LiveId" clId="{783A801E-1A91-4E3C-918C-79104B4CE9B1}" dt="2025-02-25T05:18:28.551" v="92" actId="1035"/>
          <ac:spMkLst>
            <pc:docMk/>
            <pc:sldMk cId="219075910" sldId="402"/>
            <ac:spMk id="44" creationId="{092B4C68-1A24-2B30-0FF2-8AFF4345A036}"/>
          </ac:spMkLst>
        </pc:spChg>
        <pc:spChg chg="mod">
          <ac:chgData name="薫 山形" userId="f3f449f0fe72d00b" providerId="LiveId" clId="{783A801E-1A91-4E3C-918C-79104B4CE9B1}" dt="2025-02-25T05:20:45.151" v="106" actId="1035"/>
          <ac:spMkLst>
            <pc:docMk/>
            <pc:sldMk cId="219075910" sldId="402"/>
            <ac:spMk id="46" creationId="{EF8C0694-7BDE-3F98-5B6B-2221990522B0}"/>
          </ac:spMkLst>
        </pc:spChg>
        <pc:cxnChg chg="mod">
          <ac:chgData name="薫 山形" userId="f3f449f0fe72d00b" providerId="LiveId" clId="{783A801E-1A91-4E3C-918C-79104B4CE9B1}" dt="2025-02-25T05:17:34.994" v="87" actId="14100"/>
          <ac:cxnSpMkLst>
            <pc:docMk/>
            <pc:sldMk cId="219075910" sldId="402"/>
            <ac:cxnSpMk id="11" creationId="{C7571B29-2B17-6509-CD9F-06DDCDEDBC7C}"/>
          </ac:cxnSpMkLst>
        </pc:cxnChg>
        <pc:cxnChg chg="mod">
          <ac:chgData name="薫 山形" userId="f3f449f0fe72d00b" providerId="LiveId" clId="{783A801E-1A91-4E3C-918C-79104B4CE9B1}" dt="2025-02-25T05:17:47.646" v="88" actId="14100"/>
          <ac:cxnSpMkLst>
            <pc:docMk/>
            <pc:sldMk cId="219075910" sldId="402"/>
            <ac:cxnSpMk id="22" creationId="{28D07332-A5DB-F865-CE6B-0507A5B44C34}"/>
          </ac:cxnSpMkLst>
        </pc:cxnChg>
      </pc:sldChg>
      <pc:sldChg chg="modSp mod">
        <pc:chgData name="薫 山形" userId="f3f449f0fe72d00b" providerId="LiveId" clId="{783A801E-1A91-4E3C-918C-79104B4CE9B1}" dt="2025-02-25T05:19:37.007" v="100" actId="1035"/>
        <pc:sldMkLst>
          <pc:docMk/>
          <pc:sldMk cId="1269827618" sldId="403"/>
        </pc:sldMkLst>
        <pc:spChg chg="mod">
          <ac:chgData name="薫 山形" userId="f3f449f0fe72d00b" providerId="LiveId" clId="{783A801E-1A91-4E3C-918C-79104B4CE9B1}" dt="2025-02-25T05:19:24.440" v="98" actId="1035"/>
          <ac:spMkLst>
            <pc:docMk/>
            <pc:sldMk cId="1269827618" sldId="403"/>
            <ac:spMk id="14" creationId="{CDD26DF7-D88E-DA26-A0E5-4A6B4A27334A}"/>
          </ac:spMkLst>
        </pc:spChg>
        <pc:spChg chg="mod">
          <ac:chgData name="薫 山形" userId="f3f449f0fe72d00b" providerId="LiveId" clId="{783A801E-1A91-4E3C-918C-79104B4CE9B1}" dt="2025-02-25T05:19:37.007" v="100" actId="1035"/>
          <ac:spMkLst>
            <pc:docMk/>
            <pc:sldMk cId="1269827618" sldId="403"/>
            <ac:spMk id="25" creationId="{CB637AF2-429E-BF8D-C36B-5E7237BA8226}"/>
          </ac:spMkLst>
        </pc:spChg>
      </pc:sldChg>
      <pc:sldChg chg="modSp mod">
        <pc:chgData name="薫 山形" userId="f3f449f0fe72d00b" providerId="LiveId" clId="{783A801E-1A91-4E3C-918C-79104B4CE9B1}" dt="2025-02-25T05:25:02.824" v="175" actId="1035"/>
        <pc:sldMkLst>
          <pc:docMk/>
          <pc:sldMk cId="3450967476" sldId="404"/>
        </pc:sldMkLst>
        <pc:spChg chg="mod">
          <ac:chgData name="薫 山形" userId="f3f449f0fe72d00b" providerId="LiveId" clId="{783A801E-1A91-4E3C-918C-79104B4CE9B1}" dt="2025-02-25T05:23:40.137" v="119" actId="1035"/>
          <ac:spMkLst>
            <pc:docMk/>
            <pc:sldMk cId="3450967476" sldId="404"/>
            <ac:spMk id="122" creationId="{41CD3192-54AD-3888-43A6-2F2933353661}"/>
          </ac:spMkLst>
        </pc:spChg>
        <pc:spChg chg="mod">
          <ac:chgData name="薫 山形" userId="f3f449f0fe72d00b" providerId="LiveId" clId="{783A801E-1A91-4E3C-918C-79104B4CE9B1}" dt="2025-02-25T05:23:48.616" v="121" actId="1035"/>
          <ac:spMkLst>
            <pc:docMk/>
            <pc:sldMk cId="3450967476" sldId="404"/>
            <ac:spMk id="123" creationId="{17CB124C-D98E-1597-6327-A236200664E3}"/>
          </ac:spMkLst>
        </pc:spChg>
        <pc:spChg chg="mod">
          <ac:chgData name="薫 山形" userId="f3f449f0fe72d00b" providerId="LiveId" clId="{783A801E-1A91-4E3C-918C-79104B4CE9B1}" dt="2025-02-25T05:23:48.616" v="121" actId="1035"/>
          <ac:spMkLst>
            <pc:docMk/>
            <pc:sldMk cId="3450967476" sldId="404"/>
            <ac:spMk id="125" creationId="{B25BC1E1-6787-49D9-D2DE-3EF8D2686FF5}"/>
          </ac:spMkLst>
        </pc:spChg>
        <pc:spChg chg="mod">
          <ac:chgData name="薫 山形" userId="f3f449f0fe72d00b" providerId="LiveId" clId="{783A801E-1A91-4E3C-918C-79104B4CE9B1}" dt="2025-02-25T05:23:56.453" v="125" actId="1035"/>
          <ac:spMkLst>
            <pc:docMk/>
            <pc:sldMk cId="3450967476" sldId="404"/>
            <ac:spMk id="126" creationId="{DCF13375-DEC1-FB58-8850-6FA688F2EC79}"/>
          </ac:spMkLst>
        </pc:spChg>
        <pc:spChg chg="mod">
          <ac:chgData name="薫 山形" userId="f3f449f0fe72d00b" providerId="LiveId" clId="{783A801E-1A91-4E3C-918C-79104B4CE9B1}" dt="2025-02-25T05:24:02.732" v="131" actId="1035"/>
          <ac:spMkLst>
            <pc:docMk/>
            <pc:sldMk cId="3450967476" sldId="404"/>
            <ac:spMk id="127" creationId="{184B8721-C940-5482-7407-787DBB4999A4}"/>
          </ac:spMkLst>
        </pc:spChg>
        <pc:spChg chg="mod">
          <ac:chgData name="薫 山形" userId="f3f449f0fe72d00b" providerId="LiveId" clId="{783A801E-1A91-4E3C-918C-79104B4CE9B1}" dt="2025-02-25T05:24:23.447" v="151" actId="1036"/>
          <ac:spMkLst>
            <pc:docMk/>
            <pc:sldMk cId="3450967476" sldId="404"/>
            <ac:spMk id="128" creationId="{F9946035-1753-01E3-451F-5A11AB408EBA}"/>
          </ac:spMkLst>
        </pc:spChg>
        <pc:spChg chg="mod">
          <ac:chgData name="薫 山形" userId="f3f449f0fe72d00b" providerId="LiveId" clId="{783A801E-1A91-4E3C-918C-79104B4CE9B1}" dt="2025-02-25T05:24:33.778" v="156" actId="1035"/>
          <ac:spMkLst>
            <pc:docMk/>
            <pc:sldMk cId="3450967476" sldId="404"/>
            <ac:spMk id="137" creationId="{597F78A3-788D-516D-F11D-4F9C83D29B18}"/>
          </ac:spMkLst>
        </pc:spChg>
        <pc:spChg chg="mod">
          <ac:chgData name="薫 山形" userId="f3f449f0fe72d00b" providerId="LiveId" clId="{783A801E-1A91-4E3C-918C-79104B4CE9B1}" dt="2025-02-25T05:24:33.778" v="156" actId="1035"/>
          <ac:spMkLst>
            <pc:docMk/>
            <pc:sldMk cId="3450967476" sldId="404"/>
            <ac:spMk id="138" creationId="{13DA1A5D-8C20-C0F9-93F7-1C5BEEF7FE5F}"/>
          </ac:spMkLst>
        </pc:spChg>
        <pc:spChg chg="mod">
          <ac:chgData name="薫 山形" userId="f3f449f0fe72d00b" providerId="LiveId" clId="{783A801E-1A91-4E3C-918C-79104B4CE9B1}" dt="2025-02-25T05:24:56.839" v="170" actId="1035"/>
          <ac:spMkLst>
            <pc:docMk/>
            <pc:sldMk cId="3450967476" sldId="404"/>
            <ac:spMk id="140" creationId="{DE3EF3E4-5DF1-F7D1-D1C5-E14B9921BDE6}"/>
          </ac:spMkLst>
        </pc:spChg>
        <pc:spChg chg="mod">
          <ac:chgData name="薫 山形" userId="f3f449f0fe72d00b" providerId="LiveId" clId="{783A801E-1A91-4E3C-918C-79104B4CE9B1}" dt="2025-02-25T05:25:02.824" v="175" actId="1035"/>
          <ac:spMkLst>
            <pc:docMk/>
            <pc:sldMk cId="3450967476" sldId="404"/>
            <ac:spMk id="141" creationId="{AA31ECC4-1A2A-53A2-AC95-D669B1F3E858}"/>
          </ac:spMkLst>
        </pc:spChg>
        <pc:spChg chg="mod">
          <ac:chgData name="薫 山形" userId="f3f449f0fe72d00b" providerId="LiveId" clId="{783A801E-1A91-4E3C-918C-79104B4CE9B1}" dt="2025-02-25T05:24:50.626" v="163" actId="1036"/>
          <ac:spMkLst>
            <pc:docMk/>
            <pc:sldMk cId="3450967476" sldId="404"/>
            <ac:spMk id="142" creationId="{CDF7986F-DAE1-53C3-25B6-3CA1F2B180ED}"/>
          </ac:spMkLst>
        </pc:spChg>
      </pc:sldChg>
      <pc:sldChg chg="modSp mod">
        <pc:chgData name="薫 山形" userId="f3f449f0fe72d00b" providerId="LiveId" clId="{783A801E-1A91-4E3C-918C-79104B4CE9B1}" dt="2025-02-25T05:26:11.858" v="188" actId="1036"/>
        <pc:sldMkLst>
          <pc:docMk/>
          <pc:sldMk cId="572122646" sldId="407"/>
        </pc:sldMkLst>
        <pc:spChg chg="mod">
          <ac:chgData name="薫 山形" userId="f3f449f0fe72d00b" providerId="LiveId" clId="{783A801E-1A91-4E3C-918C-79104B4CE9B1}" dt="2025-02-25T05:26:04.461" v="181" actId="1076"/>
          <ac:spMkLst>
            <pc:docMk/>
            <pc:sldMk cId="572122646" sldId="407"/>
            <ac:spMk id="33" creationId="{DE94383D-37EA-FF87-1E9F-DEED30366518}"/>
          </ac:spMkLst>
        </pc:spChg>
        <pc:spChg chg="mod">
          <ac:chgData name="薫 山形" userId="f3f449f0fe72d00b" providerId="LiveId" clId="{783A801E-1A91-4E3C-918C-79104B4CE9B1}" dt="2025-02-25T05:26:11.858" v="188" actId="1036"/>
          <ac:spMkLst>
            <pc:docMk/>
            <pc:sldMk cId="572122646" sldId="407"/>
            <ac:spMk id="36" creationId="{DA86020B-781D-89F6-8CA1-C92298918C11}"/>
          </ac:spMkLst>
        </pc:spChg>
        <pc:spChg chg="mod">
          <ac:chgData name="薫 山形" userId="f3f449f0fe72d00b" providerId="LiveId" clId="{783A801E-1A91-4E3C-918C-79104B4CE9B1}" dt="2025-02-25T05:25:49.732" v="179" actId="1035"/>
          <ac:spMkLst>
            <pc:docMk/>
            <pc:sldMk cId="572122646" sldId="407"/>
            <ac:spMk id="46" creationId="{652A0C18-D1D7-F4E4-08F0-663DCCD8547A}"/>
          </ac:spMkLst>
        </pc:spChg>
        <pc:spChg chg="mod">
          <ac:chgData name="薫 山形" userId="f3f449f0fe72d00b" providerId="LiveId" clId="{783A801E-1A91-4E3C-918C-79104B4CE9B1}" dt="2025-02-25T05:25:49.732" v="179" actId="1035"/>
          <ac:spMkLst>
            <pc:docMk/>
            <pc:sldMk cId="572122646" sldId="407"/>
            <ac:spMk id="47" creationId="{9CA06B7C-CB75-A45F-C3E4-39D5647BD40D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4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30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4AC523-6F8D-40EE-BB69-F8A09D08FEBD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9875" y="841375"/>
            <a:ext cx="170656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8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4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30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C4A2A9-0826-4AF5-93E6-2D09E70CA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8518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02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037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5448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822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983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95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494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757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834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1383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0033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30620E-97E3-4552-A110-BE61C7C44B87}" type="datetimeFigureOut">
              <a:rPr kumimoji="1" lang="ja-JP" altLang="en-US" smtClean="0"/>
              <a:t>2025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98D3E-84D9-4A20-A578-67D722C101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194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44785042-93BE-3A4D-1849-E9A984EA2F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6883" y="642245"/>
            <a:ext cx="3804234" cy="279221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162D599-362E-66C2-8FE9-B0B1A12FDE4E}"/>
              </a:ext>
            </a:extLst>
          </p:cNvPr>
          <p:cNvSpPr txBox="1"/>
          <p:nvPr/>
        </p:nvSpPr>
        <p:spPr>
          <a:xfrm>
            <a:off x="0" y="0"/>
            <a:ext cx="684205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</a:t>
            </a:r>
          </a:p>
        </p:txBody>
      </p:sp>
    </p:spTree>
    <p:extLst>
      <p:ext uri="{BB962C8B-B14F-4D97-AF65-F5344CB8AC3E}">
        <p14:creationId xmlns:p14="http://schemas.microsoft.com/office/powerpoint/2010/main" val="434133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BAAC6BB-5508-43F7-4B68-941E1C6F0AF5}"/>
              </a:ext>
            </a:extLst>
          </p:cNvPr>
          <p:cNvSpPr txBox="1"/>
          <p:nvPr/>
        </p:nvSpPr>
        <p:spPr>
          <a:xfrm>
            <a:off x="0" y="0"/>
            <a:ext cx="684205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AC5E664-8296-37DB-9913-CD12569525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7358" y="1062899"/>
            <a:ext cx="1347333" cy="2103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49071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721B310E-071E-FCEE-786E-A0042F56F2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778" y="1907817"/>
            <a:ext cx="6596444" cy="532836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F891DE5-631A-0E66-CB50-5F0AAF953C52}"/>
              </a:ext>
            </a:extLst>
          </p:cNvPr>
          <p:cNvSpPr txBox="1"/>
          <p:nvPr/>
        </p:nvSpPr>
        <p:spPr>
          <a:xfrm>
            <a:off x="0" y="0"/>
            <a:ext cx="684205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</a:t>
            </a:r>
          </a:p>
        </p:txBody>
      </p:sp>
    </p:spTree>
    <p:extLst>
      <p:ext uri="{BB962C8B-B14F-4D97-AF65-F5344CB8AC3E}">
        <p14:creationId xmlns:p14="http://schemas.microsoft.com/office/powerpoint/2010/main" val="9797363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E74CCB8-B98E-04E6-77A2-D33754F0AFDC}"/>
              </a:ext>
            </a:extLst>
          </p:cNvPr>
          <p:cNvSpPr txBox="1"/>
          <p:nvPr/>
        </p:nvSpPr>
        <p:spPr>
          <a:xfrm>
            <a:off x="0" y="0"/>
            <a:ext cx="687199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AA59E0F1-17B2-48A0-6F66-5BA4D98485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98883"/>
            <a:ext cx="6858000" cy="19731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877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78</TotalTime>
  <Words>16</Words>
  <Application>Microsoft Office PowerPoint</Application>
  <PresentationFormat>画面に合わせる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塚隆史</dc:creator>
  <cp:lastModifiedBy>隆史 大塚</cp:lastModifiedBy>
  <cp:revision>1472</cp:revision>
  <cp:lastPrinted>2025-02-25T05:22:16Z</cp:lastPrinted>
  <dcterms:created xsi:type="dcterms:W3CDTF">2020-04-30T03:28:07Z</dcterms:created>
  <dcterms:modified xsi:type="dcterms:W3CDTF">2025-03-02T03:04:44Z</dcterms:modified>
</cp:coreProperties>
</file>